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CA44C-A78F-4336-8DBC-890871FC6F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7A161-D7C3-4C2E-AF82-EB67464BAC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C2171-D4E4-4ABE-AAD7-F8155E7AD1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56D32-EEFD-4C50-BBE3-3243A7B1D2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5404CB-E536-4F87-9233-8CE08A6562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459DB-5966-4DFC-AF57-82E571C5B8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B03A6-211E-4E96-AC40-C72944F89E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29469-1B20-46E6-94C7-68CBEF37C2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D87C6-B8AB-497B-98F7-B068D55708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0F76D-0271-43F3-8F82-875DAD50AD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BAA83-FD64-4F14-ABEF-063491E34D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12F83-135E-454C-BF24-00010F42B6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379D6B-5E23-4BE5-877F-A0BA1BBD9803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5"/>
          <p:cNvSpPr/>
          <p:nvPr/>
        </p:nvSpPr>
        <p:spPr>
          <a:xfrm>
            <a:off x="194040" y="115920"/>
            <a:ext cx="293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グループ化 21"/>
          <p:cNvGrpSpPr/>
          <p:nvPr/>
        </p:nvGrpSpPr>
        <p:grpSpPr>
          <a:xfrm>
            <a:off x="1717560" y="836640"/>
            <a:ext cx="5734080" cy="5141520"/>
            <a:chOff x="1717560" y="836640"/>
            <a:chExt cx="5734080" cy="5141520"/>
          </a:xfrm>
        </p:grpSpPr>
        <p:pic>
          <p:nvPicPr>
            <p:cNvPr id="43" name="グラフ 3" descr=""/>
            <p:cNvPicPr/>
            <p:nvPr/>
          </p:nvPicPr>
          <p:blipFill>
            <a:blip r:embed="rId1"/>
            <a:stretch/>
          </p:blipFill>
          <p:spPr>
            <a:xfrm>
              <a:off x="2133000" y="1231200"/>
              <a:ext cx="2278440" cy="4523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グラフ 4" descr=""/>
            <p:cNvPicPr/>
            <p:nvPr/>
          </p:nvPicPr>
          <p:blipFill>
            <a:blip r:embed="rId2"/>
            <a:stretch/>
          </p:blipFill>
          <p:spPr>
            <a:xfrm>
              <a:off x="5234040" y="1158120"/>
              <a:ext cx="2217600" cy="460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テキスト ボックス 8"/>
            <p:cNvSpPr/>
            <p:nvPr/>
          </p:nvSpPr>
          <p:spPr>
            <a:xfrm rot="16200000">
              <a:off x="831240" y="3395880"/>
              <a:ext cx="2292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expression rati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( /RNU6 expression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テキスト ボックス 9"/>
            <p:cNvSpPr/>
            <p:nvPr/>
          </p:nvSpPr>
          <p:spPr>
            <a:xfrm>
              <a:off x="6074280" y="1362240"/>
              <a:ext cx="95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= 0.34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テキスト ボックス 8"/>
            <p:cNvSpPr/>
            <p:nvPr/>
          </p:nvSpPr>
          <p:spPr>
            <a:xfrm rot="16200000">
              <a:off x="3937320" y="3395880"/>
              <a:ext cx="2292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expression rati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( /RNU6 expression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058"/>
            <p:cNvSpPr/>
            <p:nvPr/>
          </p:nvSpPr>
          <p:spPr>
            <a:xfrm>
              <a:off x="4340880" y="1304280"/>
              <a:ext cx="15829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Wilcoxon t-tes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テキスト ボックス 9"/>
            <p:cNvSpPr/>
            <p:nvPr/>
          </p:nvSpPr>
          <p:spPr>
            <a:xfrm>
              <a:off x="3034080" y="1362240"/>
              <a:ext cx="95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= 0.01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テキスト ボックス 10"/>
            <p:cNvSpPr/>
            <p:nvPr/>
          </p:nvSpPr>
          <p:spPr>
            <a:xfrm>
              <a:off x="3358800" y="836640"/>
              <a:ext cx="2936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expression in tissue sampl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テキスト ボックス 11"/>
            <p:cNvSpPr/>
            <p:nvPr/>
          </p:nvSpPr>
          <p:spPr>
            <a:xfrm>
              <a:off x="3065760" y="5701680"/>
              <a:ext cx="77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R-45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テキスト ボックス 12"/>
            <p:cNvSpPr/>
            <p:nvPr/>
          </p:nvSpPr>
          <p:spPr>
            <a:xfrm>
              <a:off x="6028920" y="5694120"/>
              <a:ext cx="77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R-48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グループ化 16"/>
            <p:cNvGrpSpPr/>
            <p:nvPr/>
          </p:nvGrpSpPr>
          <p:grpSpPr>
            <a:xfrm>
              <a:off x="3048120" y="1649160"/>
              <a:ext cx="899280" cy="120600"/>
              <a:chOff x="3048120" y="1649160"/>
              <a:chExt cx="899280" cy="120600"/>
            </a:xfrm>
          </p:grpSpPr>
          <p:sp>
            <p:nvSpPr>
              <p:cNvPr id="54" name="直線コネクタ 13"/>
              <p:cNvSpPr/>
              <p:nvPr/>
            </p:nvSpPr>
            <p:spPr>
              <a:xfrm>
                <a:off x="3060720" y="1661760"/>
                <a:ext cx="0" cy="108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直線コネクタ 14"/>
              <p:cNvSpPr/>
              <p:nvPr/>
            </p:nvSpPr>
            <p:spPr>
              <a:xfrm>
                <a:off x="3938040" y="1661760"/>
                <a:ext cx="0" cy="108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直線コネクタ 15"/>
              <p:cNvSpPr/>
              <p:nvPr/>
            </p:nvSpPr>
            <p:spPr>
              <a:xfrm>
                <a:off x="3048120" y="1649160"/>
                <a:ext cx="899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グループ化 17"/>
            <p:cNvGrpSpPr/>
            <p:nvPr/>
          </p:nvGrpSpPr>
          <p:grpSpPr>
            <a:xfrm>
              <a:off x="6083640" y="1649160"/>
              <a:ext cx="899280" cy="120600"/>
              <a:chOff x="6083640" y="1649160"/>
              <a:chExt cx="899280" cy="120600"/>
            </a:xfrm>
          </p:grpSpPr>
          <p:sp>
            <p:nvSpPr>
              <p:cNvPr id="58" name="直線コネクタ 18"/>
              <p:cNvSpPr/>
              <p:nvPr/>
            </p:nvSpPr>
            <p:spPr>
              <a:xfrm>
                <a:off x="6096240" y="1661760"/>
                <a:ext cx="0" cy="108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直線コネクタ 19"/>
              <p:cNvSpPr/>
              <p:nvPr/>
            </p:nvSpPr>
            <p:spPr>
              <a:xfrm>
                <a:off x="6972120" y="1661760"/>
                <a:ext cx="0" cy="108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直線コネクタ 20"/>
              <p:cNvSpPr/>
              <p:nvPr/>
            </p:nvSpPr>
            <p:spPr>
              <a:xfrm>
                <a:off x="6083640" y="1649160"/>
                <a:ext cx="899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3T12:14:44Z</dcterms:created>
  <dc:creator>hirotaka</dc:creator>
  <dc:description/>
  <dc:language>en-US</dc:language>
  <cp:lastModifiedBy>hirotaka</cp:lastModifiedBy>
  <dcterms:modified xsi:type="dcterms:W3CDTF">2011-10-13T10:02:36Z</dcterms:modified>
  <cp:revision>12</cp:revision>
  <dc:subject/>
  <dc:title>スライド 1</dc:title>
</cp:coreProperties>
</file>